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192000" cy="1920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444" y="-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3142616"/>
            <a:ext cx="10363200" cy="668528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10085706"/>
            <a:ext cx="9144000" cy="463613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138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485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1022350"/>
            <a:ext cx="2628900" cy="1627314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1022350"/>
            <a:ext cx="7734300" cy="1627314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485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67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787270"/>
            <a:ext cx="10515600" cy="798766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2850500"/>
            <a:ext cx="10515600" cy="420052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986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5111750"/>
            <a:ext cx="5181600" cy="1218374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5111750"/>
            <a:ext cx="5181600" cy="1218374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997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22354"/>
            <a:ext cx="10515600" cy="37115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4707256"/>
            <a:ext cx="5157787" cy="230695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7014210"/>
            <a:ext cx="5157787" cy="1031684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707256"/>
            <a:ext cx="5183188" cy="230695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7014210"/>
            <a:ext cx="5183188" cy="1031684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1292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596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284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80160"/>
            <a:ext cx="3932237" cy="448056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764794"/>
            <a:ext cx="6172200" cy="1364615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760720"/>
            <a:ext cx="3932237" cy="1067244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2012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80160"/>
            <a:ext cx="3932237" cy="448056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764794"/>
            <a:ext cx="6172200" cy="1364615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760720"/>
            <a:ext cx="3932237" cy="1067244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956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1022354"/>
            <a:ext cx="10515600" cy="37115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5111750"/>
            <a:ext cx="10515600" cy="1218374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7797784"/>
            <a:ext cx="2743200" cy="1022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72D9C1-543F-4D52-81D7-4EAD78FAA081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7797784"/>
            <a:ext cx="4114800" cy="1022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7797784"/>
            <a:ext cx="2743200" cy="10223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20D8C-B47B-446A-8D29-79DD52B53F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96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5E53BD3-609E-4716-B47D-5EE333B20EA2}"/>
              </a:ext>
            </a:extLst>
          </p:cNvPr>
          <p:cNvSpPr txBox="1"/>
          <p:nvPr/>
        </p:nvSpPr>
        <p:spPr>
          <a:xfrm>
            <a:off x="315844" y="412458"/>
            <a:ext cx="112774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Forward and reverse primers used to amplify and validate the overlapping regions present in all four possible junctions (LSC-IR, IR-SSC, SSC-IR, and IR-LSC) of eight chloroplast genomes.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14648D8-CE9A-4F0A-AEBD-923A05AE97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002051"/>
              </p:ext>
            </p:extLst>
          </p:nvPr>
        </p:nvGraphicFramePr>
        <p:xfrm>
          <a:off x="2472855" y="1240971"/>
          <a:ext cx="7979575" cy="1754897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00869">
                  <a:extLst>
                    <a:ext uri="{9D8B030D-6E8A-4147-A177-3AD203B41FA5}">
                      <a16:colId xmlns:a16="http://schemas.microsoft.com/office/drawing/2014/main" val="3512831776"/>
                    </a:ext>
                  </a:extLst>
                </a:gridCol>
                <a:gridCol w="941294">
                  <a:extLst>
                    <a:ext uri="{9D8B030D-6E8A-4147-A177-3AD203B41FA5}">
                      <a16:colId xmlns:a16="http://schemas.microsoft.com/office/drawing/2014/main" val="3728161301"/>
                    </a:ext>
                  </a:extLst>
                </a:gridCol>
                <a:gridCol w="941294">
                  <a:extLst>
                    <a:ext uri="{9D8B030D-6E8A-4147-A177-3AD203B41FA5}">
                      <a16:colId xmlns:a16="http://schemas.microsoft.com/office/drawing/2014/main" val="4290900479"/>
                    </a:ext>
                  </a:extLst>
                </a:gridCol>
                <a:gridCol w="968188">
                  <a:extLst>
                    <a:ext uri="{9D8B030D-6E8A-4147-A177-3AD203B41FA5}">
                      <a16:colId xmlns:a16="http://schemas.microsoft.com/office/drawing/2014/main" val="761429402"/>
                    </a:ext>
                  </a:extLst>
                </a:gridCol>
                <a:gridCol w="2635624">
                  <a:extLst>
                    <a:ext uri="{9D8B030D-6E8A-4147-A177-3AD203B41FA5}">
                      <a16:colId xmlns:a16="http://schemas.microsoft.com/office/drawing/2014/main" val="3586232620"/>
                    </a:ext>
                  </a:extLst>
                </a:gridCol>
                <a:gridCol w="1192306">
                  <a:extLst>
                    <a:ext uri="{9D8B030D-6E8A-4147-A177-3AD203B41FA5}">
                      <a16:colId xmlns:a16="http://schemas.microsoft.com/office/drawing/2014/main" val="2762727061"/>
                    </a:ext>
                  </a:extLst>
                </a:gridCol>
              </a:tblGrid>
              <a:tr h="2514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es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unction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Name</a:t>
                      </a:r>
                      <a:endParaRPr lang="en-US" sz="1200" b="1" i="0" u="none" strike="noStrike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rectionality</a:t>
                      </a:r>
                      <a:endParaRPr lang="en-US" sz="1200" b="1" i="0" u="none" strike="noStrike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2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 Size</a:t>
                      </a:r>
                      <a:endParaRPr lang="en-US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2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9716018"/>
                  </a:ext>
                </a:extLst>
              </a:tr>
              <a:tr h="25142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troflexus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C-IR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GTTTCAACTTCAACCAAT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0330587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AAACTGCTCAGCAAC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76829159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-SS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AGGATGAATTCCACT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2735200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TTTCGATTTCCTTG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45764079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-IRB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AATTTGAATGAGTCCGT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5329241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GAGTGAATGGAAAGG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94299842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B-L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CGGACAAGTGGGAAA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6092367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GCTCGATAGGGCATA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95678149"/>
                  </a:ext>
                </a:extLst>
              </a:tr>
              <a:tr h="25142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ricat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C-IR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GCTCGATAAGGCATG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409605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CTAGGTAAGCGTCCTG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1026615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-SS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AAGGGGCTGAATTGG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581814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GTTTGGCTGAACTAATTT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0072912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-IR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GATCGTGGTTTTCT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37332953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AAGGGGCTGAATTGGT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8250390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B-L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GTGGGGAATGTTGGA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29979337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GGCGGATATCATTAAC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2091135"/>
                  </a:ext>
                </a:extLst>
              </a:tr>
              <a:tr h="25142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opter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C-IR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TGCTATTGAAGCTCCA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2801095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AAACTGCTCAGCAA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67354776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-S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1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AATGCCGTCACCTA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872140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GTCGAATTTCTTCC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30932122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-IR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TTTTGAGTTTTATCGT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9849716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AGAAATTCTATGGCTCG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3820963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B-L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AAACTGCTCAGCAA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335672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CTGCTGCAGAATAAAT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6422003"/>
                  </a:ext>
                </a:extLst>
              </a:tr>
              <a:tr h="25142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nuspersici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C-IR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TGCTATTGAAGCTCCAT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176487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AAACTGCTCAGCAA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7825296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-S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AATGCCGTCACCTA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683869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GTCGAATTTCTTCC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16570759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-IR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TTTTGAGTTTTATCGT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1547401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AATGCCGTCACCTA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35305628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B-L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CTGCTCAGCAACAGTC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0615735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CCTAGCATTTGCTG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8735863"/>
                  </a:ext>
                </a:extLst>
              </a:tr>
              <a:tr h="25142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.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modendrum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C-IR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CGATAGGGCATGAGT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4410989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AAAACTGCTCAGCAA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50454009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-S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CTTTGGCCCAATTATC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1267067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TTCGCAATCAATAACA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7954183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-IR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CTTTTATTTCCCTCC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1732960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AAACAAATAGGAAATCGGG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13577560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B-L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CAGCAACAGTCGGACA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4175625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CCTTCAACCTAAATG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4707499"/>
                  </a:ext>
                </a:extLst>
              </a:tr>
              <a:tr h="25142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.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alocaspic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C-IR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ACCGTAAAGGGGCAG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1325175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TATTGGAATTGGTGTG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1213843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-S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AGAAGAGGGATTCATC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88563667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GGGATTGGTATGAATT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38172713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-IR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ACCACGATGAGATCCGT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271998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GAAACGGAGAAGACTAAACAG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3088881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B-L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TATTGGAATTGGTGTGG   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480764"/>
                  </a:ext>
                </a:extLst>
              </a:tr>
              <a:tr h="3347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CTCCCCAGAGGGTAATTT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8701952"/>
                  </a:ext>
                </a:extLst>
              </a:tr>
              <a:tr h="251426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aeda</a:t>
                      </a:r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ltonic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C-IR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4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ATTCCAATGGATATTGGTTG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8471813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AGAAGTTACCAAGGAACCA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0922598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-S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AGACAGGGAAGGGGT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4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8065206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AGAGACGCGACTTGA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991419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ATTGAGATGATTCGTAGTTTC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0569091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TAGGTGACGGCATTC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40370376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-IR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GTGACATTTCATTTCTTACC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1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4109852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ACTCTTAACAGCCAAAGCGA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9662045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AATCGAATCATTTTGC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9257679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GTTTTATTTTCGCCAT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28426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B-L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5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AGAAGTTACCAAGGAACCA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566945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ATTAGGGTCGTATTCTATG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78745466"/>
                  </a:ext>
                </a:extLst>
              </a:tr>
              <a:tr h="251426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1200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. </a:t>
                      </a:r>
                      <a:r>
                        <a:rPr lang="en-US" sz="1200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itim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SC-IR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CATAACTTCCCTCTAGAC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2011120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TATGAACCCTGTAGACCATC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4614127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A-S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CAAAGGATGAATTCCACTTGT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742982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TCGATTAGTATAGCTTATGCAGG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38514199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C-IR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TTGATCTTCCCAACCTATTT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744245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AATAGAGACAATTCGGAAAC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59932344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RB-LS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AAAATTACCTTCTGGGGAGG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8302002"/>
                  </a:ext>
                </a:extLst>
              </a:tr>
              <a:tr h="2514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_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GATCAATTACTCTTCGTGCT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2872" marR="2872" marT="287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607386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91418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75</Words>
  <Application>Microsoft Office PowerPoint</Application>
  <PresentationFormat>Custom</PresentationFormat>
  <Paragraphs>28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uce Williamson Benavides</dc:creator>
  <cp:lastModifiedBy>Amit Dhingra</cp:lastModifiedBy>
  <cp:revision>2</cp:revision>
  <dcterms:created xsi:type="dcterms:W3CDTF">2020-04-14T03:21:30Z</dcterms:created>
  <dcterms:modified xsi:type="dcterms:W3CDTF">2020-04-17T10:27:15Z</dcterms:modified>
</cp:coreProperties>
</file>